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134" d="100"/>
          <a:sy n="134" d="100"/>
        </p:scale>
        <p:origin x="-496" y="-10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2384B3-44C0-424E-B9E1-4A102FEB35D4}" type="datetimeFigureOut">
              <a:rPr lang="en-US" smtClean="0"/>
              <a:t>9/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FED29-4CB9-4B40-BC79-50E7278A21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12435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2384B3-44C0-424E-B9E1-4A102FEB35D4}" type="datetimeFigureOut">
              <a:rPr lang="en-US" smtClean="0"/>
              <a:t>9/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FED29-4CB9-4B40-BC79-50E7278A21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09666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2384B3-44C0-424E-B9E1-4A102FEB35D4}" type="datetimeFigureOut">
              <a:rPr lang="en-US" smtClean="0"/>
              <a:t>9/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FED29-4CB9-4B40-BC79-50E7278A21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61882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2384B3-44C0-424E-B9E1-4A102FEB35D4}" type="datetimeFigureOut">
              <a:rPr lang="en-US" smtClean="0"/>
              <a:t>9/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FED29-4CB9-4B40-BC79-50E7278A21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22491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2384B3-44C0-424E-B9E1-4A102FEB35D4}" type="datetimeFigureOut">
              <a:rPr lang="en-US" smtClean="0"/>
              <a:t>9/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FED29-4CB9-4B40-BC79-50E7278A21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07319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2384B3-44C0-424E-B9E1-4A102FEB35D4}" type="datetimeFigureOut">
              <a:rPr lang="en-US" smtClean="0"/>
              <a:t>9/9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FED29-4CB9-4B40-BC79-50E7278A21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84540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2384B3-44C0-424E-B9E1-4A102FEB35D4}" type="datetimeFigureOut">
              <a:rPr lang="en-US" smtClean="0"/>
              <a:t>9/9/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FED29-4CB9-4B40-BC79-50E7278A21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980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2384B3-44C0-424E-B9E1-4A102FEB35D4}" type="datetimeFigureOut">
              <a:rPr lang="en-US" smtClean="0"/>
              <a:t>9/9/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FED29-4CB9-4B40-BC79-50E7278A21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10285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2384B3-44C0-424E-B9E1-4A102FEB35D4}" type="datetimeFigureOut">
              <a:rPr lang="en-US" smtClean="0"/>
              <a:t>9/9/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FED29-4CB9-4B40-BC79-50E7278A21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74045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2384B3-44C0-424E-B9E1-4A102FEB35D4}" type="datetimeFigureOut">
              <a:rPr lang="en-US" smtClean="0"/>
              <a:t>9/9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FED29-4CB9-4B40-BC79-50E7278A21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66629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2384B3-44C0-424E-B9E1-4A102FEB35D4}" type="datetimeFigureOut">
              <a:rPr lang="en-US" smtClean="0"/>
              <a:t>9/9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EFED29-4CB9-4B40-BC79-50E7278A21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50313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2384B3-44C0-424E-B9E1-4A102FEB35D4}" type="datetimeFigureOut">
              <a:rPr lang="en-US" smtClean="0"/>
              <a:t>9/9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EFED29-4CB9-4B40-BC79-50E7278A21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46888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Screen Shot 2014-12-10 at 4.38.44 PM.png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31" r="1687"/>
          <a:stretch/>
        </p:blipFill>
        <p:spPr>
          <a:xfrm>
            <a:off x="461602" y="624953"/>
            <a:ext cx="5951898" cy="2765098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6327648" y="8672084"/>
            <a:ext cx="4670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S4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Rectangle 3"/>
          <p:cNvSpPr/>
          <p:nvPr/>
        </p:nvSpPr>
        <p:spPr>
          <a:xfrm>
            <a:off x="576242" y="3566493"/>
            <a:ext cx="5751405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dirty="0"/>
              <a:t>Supplemental Figure </a:t>
            </a:r>
            <a:r>
              <a:rPr lang="en-US" sz="1400" dirty="0"/>
              <a:t>4</a:t>
            </a:r>
            <a:r>
              <a:rPr lang="en-US" sz="1400" dirty="0" smtClean="0"/>
              <a:t>. </a:t>
            </a:r>
            <a:r>
              <a:rPr lang="en-US" sz="1400" dirty="0"/>
              <a:t>Distribution of </a:t>
            </a:r>
            <a:r>
              <a:rPr lang="en-US" sz="1400" dirty="0" smtClean="0"/>
              <a:t>2,938 transcripts </a:t>
            </a:r>
            <a:r>
              <a:rPr lang="en-US" sz="1400" dirty="0"/>
              <a:t>among the super-clusters. The graph shows the distribution of known and novel </a:t>
            </a:r>
            <a:r>
              <a:rPr lang="en-US" sz="1400" dirty="0" smtClean="0"/>
              <a:t>transcripts </a:t>
            </a:r>
            <a:r>
              <a:rPr lang="en-US" sz="1400" dirty="0"/>
              <a:t>belonging to different </a:t>
            </a:r>
            <a:r>
              <a:rPr lang="en-US" sz="1400" dirty="0" err="1"/>
              <a:t>Cuffcompare</a:t>
            </a:r>
            <a:r>
              <a:rPr lang="en-US" sz="1400" dirty="0"/>
              <a:t> classes among six super-clusters.</a:t>
            </a:r>
          </a:p>
        </p:txBody>
      </p:sp>
    </p:spTree>
    <p:extLst>
      <p:ext uri="{BB962C8B-B14F-4D97-AF65-F5344CB8AC3E}">
        <p14:creationId xmlns:p14="http://schemas.microsoft.com/office/powerpoint/2010/main" val="1188174132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4</TotalTime>
  <Words>36</Words>
  <Application>Microsoft Macintosh PowerPoint</Application>
  <PresentationFormat>Letter Paper (8.5x11 in)</PresentationFormat>
  <Paragraphs>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Virginia Tech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elasa Aghamirzaie</dc:creator>
  <cp:lastModifiedBy>Delasa Aghamirzaie</cp:lastModifiedBy>
  <cp:revision>10</cp:revision>
  <dcterms:created xsi:type="dcterms:W3CDTF">2014-12-05T21:51:48Z</dcterms:created>
  <dcterms:modified xsi:type="dcterms:W3CDTF">2015-09-09T18:09:06Z</dcterms:modified>
</cp:coreProperties>
</file>